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0" r:id="rId2"/>
    <p:sldId id="256" r:id="rId3"/>
    <p:sldId id="258" r:id="rId4"/>
    <p:sldId id="259" r:id="rId5"/>
    <p:sldId id="257" r:id="rId6"/>
  </p:sldIdLst>
  <p:sldSz cx="12192000" cy="6858000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166" autoAdjust="0"/>
    <p:restoredTop sz="78699" autoAdjust="0"/>
  </p:normalViewPr>
  <p:slideViewPr>
    <p:cSldViewPr snapToGrid="0">
      <p:cViewPr varScale="1">
        <p:scale>
          <a:sx n="57" d="100"/>
          <a:sy n="57" d="100"/>
        </p:scale>
        <p:origin x="133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κεφαλίδας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3" name="Θέση ημερομηνίας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E60E3D-286E-4A99-9C21-C7ACA4B081E5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4" name="Θέση εικόνας διαφάνειας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l-GR"/>
          </a:p>
        </p:txBody>
      </p:sp>
      <p:sp>
        <p:nvSpPr>
          <p:cNvPr id="5" name="Θέση σημειώσεων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48AFB6-8614-45B7-BB7E-3FB0C083D4E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974627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ry Figure 4a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unnel plot for the comparison </a:t>
            </a:r>
            <a:r>
              <a:rPr lang="en-US" sz="1800" dirty="0"/>
              <a:t>of circulating FGF-21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etween patients with NAFLD and controls, in sensitivity analysis after excluding studies with pediatric/adolescent populations</a:t>
            </a:r>
          </a:p>
          <a:p>
            <a:r>
              <a:rPr lang="en-US" dirty="0"/>
              <a:t>Abbreviations: FGF-21, fibroblast growth factor-21; NAFLD, nonalcoholic fatty liver disease; n, number of excluded studies</a:t>
            </a:r>
            <a:endParaRPr lang="el-GR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48AFB6-8614-45B7-BB7E-3FB0C083D4E9}" type="slidenum">
              <a:rPr lang="el-GR" smtClean="0"/>
              <a:t>1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12764508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ry Figure 4b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unnel plot for the comparison of</a:t>
            </a:r>
            <a:r>
              <a:rPr lang="en-US" sz="1800" dirty="0"/>
              <a:t> circulating FGF-21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etween patients with NAFLD and controls, in sensitivity analysis after excluding studies with morbidly obese populations subjected to bariatric surgery</a:t>
            </a:r>
          </a:p>
          <a:p>
            <a:r>
              <a:rPr lang="en-US" dirty="0"/>
              <a:t>Abbreviations: FGF-21, fibroblast growth factor-21; NAFLD, nonalcoholic fatty liver disease; n, number of excluded studies</a:t>
            </a:r>
            <a:endParaRPr lang="el-GR" dirty="0"/>
          </a:p>
          <a:p>
            <a:endParaRPr lang="el-GR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48AFB6-8614-45B7-BB7E-3FB0C083D4E9}" type="slidenum">
              <a:rPr lang="el-GR" smtClean="0"/>
              <a:t>2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10025097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ry Figure 4c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unnel plot for the comparison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of </a:t>
            </a:r>
            <a:r>
              <a:rPr lang="en-US" sz="1800" dirty="0"/>
              <a:t>circulating FGF-21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etween patients with NAFLD and controls, in sensitivity analysis after excluding studies with NOS score &lt;7</a:t>
            </a:r>
          </a:p>
          <a:p>
            <a:r>
              <a:rPr lang="en-US" dirty="0"/>
              <a:t>Abbreviations: FGF-21, fibroblast growth factor-21; NAFLD, nonalcoholic fatty liver disease; NOS, Newcastle Ottawa score; n, number of excluded studies</a:t>
            </a:r>
            <a:endParaRPr lang="el-GR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48AFB6-8614-45B7-BB7E-3FB0C083D4E9}" type="slidenum">
              <a:rPr lang="el-GR" smtClean="0"/>
              <a:t>3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58355281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ry Figure 4d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unnel plot for the comparison of</a:t>
            </a:r>
            <a:r>
              <a:rPr lang="en-US" sz="1800" dirty="0"/>
              <a:t> circulating FGF-21 levels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etween patients with NAFLD and controls, in sensitivity analysis after excluding studies with </a:t>
            </a:r>
            <a:r>
              <a:rPr lang="en-US" sz="1800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outliers of FGF-21 SMD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dirty="0"/>
              <a:t>Abbreviations: FGF-21, fibroblast growth factor-21; MAFLD, metabolic-disfunction associated fatty liver disease; n, number of excluded studies; SMD, standardized mean difference</a:t>
            </a:r>
            <a:endParaRPr lang="el-GR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48AFB6-8614-45B7-BB7E-3FB0C083D4E9}" type="slidenum">
              <a:rPr lang="el-GR" smtClean="0"/>
              <a:t>4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65423108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ry </a:t>
            </a:r>
            <a:r>
              <a:rPr lang="en-US" b="1"/>
              <a:t>Figure 4e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unnel plot for the comparison of </a:t>
            </a:r>
            <a:r>
              <a:rPr lang="en-US" sz="1800" dirty="0"/>
              <a:t>FGF-21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etween patients with NAFLD and controls, in sensitivity analysis after excluding studies with </a:t>
            </a:r>
            <a:r>
              <a:rPr lang="en-US" sz="1800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the use of the definition of MAFLD for the diagnosis of </a:t>
            </a:r>
            <a:r>
              <a:rPr lang="en-US" sz="1800" kern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the disease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dirty="0"/>
              <a:t>Abbreviations: FGF-21, fibroblast growth factor-21; MAFLD, metabolic-dysfunction associated fatty liver disease; NAFLD, nonalcoholic fatty liver disease; n, number of excluded studies</a:t>
            </a:r>
            <a:endParaRPr lang="el-GR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48AFB6-8614-45B7-BB7E-3FB0C083D4E9}" type="slidenum">
              <a:rPr lang="el-GR" smtClean="0"/>
              <a:t>5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2827574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52A50373-2FD1-DF07-435C-ED1D5E6AF92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Υπότιτλος 2">
            <a:extLst>
              <a:ext uri="{FF2B5EF4-FFF2-40B4-BE49-F238E27FC236}">
                <a16:creationId xmlns:a16="http://schemas.microsoft.com/office/drawing/2014/main" id="{7E9524CA-E1E2-3A49-C9AB-F9A1434A28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2AA115E4-1CE9-C86A-CA16-55D87379C5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FA3B6-098D-4AFF-A6E1-6FF6E547B543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168BD772-573D-983F-A777-088D5978D9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FED9C956-51F1-3A34-37B5-FC1FD6D141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8ADE6-8438-47CA-8259-E752C44071B0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4933695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C570330A-3A29-AB61-E1D6-24BDA6686A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ατακόρυφου κειμένου 2">
            <a:extLst>
              <a:ext uri="{FF2B5EF4-FFF2-40B4-BE49-F238E27FC236}">
                <a16:creationId xmlns:a16="http://schemas.microsoft.com/office/drawing/2014/main" id="{BE2761E4-7CBE-7AB2-43F5-8C40C1CDFA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F0FDBE38-B92C-4B18-8BDB-D2A38CCCD5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FA3B6-098D-4AFF-A6E1-6FF6E547B543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0397FE54-8F07-F87B-5651-7F6C5332FC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1321DA32-19E5-2110-5312-09E49EB62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8ADE6-8438-47CA-8259-E752C44071B0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7210639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Κατακόρυφος τίτλος 1">
            <a:extLst>
              <a:ext uri="{FF2B5EF4-FFF2-40B4-BE49-F238E27FC236}">
                <a16:creationId xmlns:a16="http://schemas.microsoft.com/office/drawing/2014/main" id="{B79B46E0-7361-F229-8FD2-FB82946D773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ατακόρυφου κειμένου 2">
            <a:extLst>
              <a:ext uri="{FF2B5EF4-FFF2-40B4-BE49-F238E27FC236}">
                <a16:creationId xmlns:a16="http://schemas.microsoft.com/office/drawing/2014/main" id="{67E87DD2-F123-2EFA-0503-AE3E41448D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BF174132-4C90-DA82-38C0-106C55656A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FA3B6-098D-4AFF-A6E1-6FF6E547B543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C678F743-0670-051B-09A4-EB531D7C09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9F36B37D-DEFA-FC6D-A132-6D80130796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8ADE6-8438-47CA-8259-E752C44071B0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7463591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8297F6D1-1EA9-B13D-C117-2634002236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21B470E6-50EB-DE6C-B8CC-1A3065D8F7B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7BF4FB18-BE88-3DD8-4BEA-9D6503CDAF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FA3B6-098D-4AFF-A6E1-6FF6E547B543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82074A4B-DD0E-DCE5-C834-385A365F7B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51700F1E-4249-1473-8EA9-3BC6B8BC40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8ADE6-8438-47CA-8259-E752C44071B0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201535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366A3C18-1DFB-FBAE-DF10-CE42D23F5B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45DEDC91-A7A5-8005-FB56-BF9E080511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A2DB4ABD-FBEB-953B-B12A-732588E885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FA3B6-098D-4AFF-A6E1-6FF6E547B543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DA2A91F0-2500-6B95-5076-E5478B23B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CB809C67-31B8-EF12-C38E-5D0CE2663B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8ADE6-8438-47CA-8259-E752C44071B0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7835464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64F9DE69-A8DB-488C-F3C5-C1AFC06553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B09B3C89-7FCC-6971-350C-81E91396898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περιεχομένου 3">
            <a:extLst>
              <a:ext uri="{FF2B5EF4-FFF2-40B4-BE49-F238E27FC236}">
                <a16:creationId xmlns:a16="http://schemas.microsoft.com/office/drawing/2014/main" id="{EE0E57AA-5C1F-842D-B19A-B05195A248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ACA012BC-743D-C7C8-6F1C-1AA85FAABA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FA3B6-098D-4AFF-A6E1-6FF6E547B543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6EB0D079-0311-98DF-2DE5-09FBD7EBB1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3DE81B99-1E20-70F2-B42E-F582A66307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8ADE6-8438-47CA-8259-E752C44071B0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922286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B3D4C8F0-27BB-3064-BFE4-820930F01D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B1FD3420-BAD1-BA3A-2353-85397A1BA8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Θέση περιεχομένου 3">
            <a:extLst>
              <a:ext uri="{FF2B5EF4-FFF2-40B4-BE49-F238E27FC236}">
                <a16:creationId xmlns:a16="http://schemas.microsoft.com/office/drawing/2014/main" id="{19E9EB74-1710-01AE-DE91-DC08E1D483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5" name="Θέση κειμένου 4">
            <a:extLst>
              <a:ext uri="{FF2B5EF4-FFF2-40B4-BE49-F238E27FC236}">
                <a16:creationId xmlns:a16="http://schemas.microsoft.com/office/drawing/2014/main" id="{CAE9BEEE-CFF0-2718-E944-FBE40CC783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6" name="Θέση περιεχομένου 5">
            <a:extLst>
              <a:ext uri="{FF2B5EF4-FFF2-40B4-BE49-F238E27FC236}">
                <a16:creationId xmlns:a16="http://schemas.microsoft.com/office/drawing/2014/main" id="{CA998BD0-D718-5D6D-0FA2-D36B26DFBE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7" name="Θέση ημερομηνίας 6">
            <a:extLst>
              <a:ext uri="{FF2B5EF4-FFF2-40B4-BE49-F238E27FC236}">
                <a16:creationId xmlns:a16="http://schemas.microsoft.com/office/drawing/2014/main" id="{05C7A5AE-67F5-77E7-5839-462FACA586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FA3B6-098D-4AFF-A6E1-6FF6E547B543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8" name="Θέση υποσέλιδου 7">
            <a:extLst>
              <a:ext uri="{FF2B5EF4-FFF2-40B4-BE49-F238E27FC236}">
                <a16:creationId xmlns:a16="http://schemas.microsoft.com/office/drawing/2014/main" id="{9249FF50-1F77-E63A-D4C9-551B96BB0B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Θέση αριθμού διαφάνειας 8">
            <a:extLst>
              <a:ext uri="{FF2B5EF4-FFF2-40B4-BE49-F238E27FC236}">
                <a16:creationId xmlns:a16="http://schemas.microsoft.com/office/drawing/2014/main" id="{6B684274-067C-E604-B2CB-6F0791F7BC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8ADE6-8438-47CA-8259-E752C44071B0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129078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0C0D9C76-8CD4-C962-1A24-F5FD4B3BB9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ημερομηνίας 2">
            <a:extLst>
              <a:ext uri="{FF2B5EF4-FFF2-40B4-BE49-F238E27FC236}">
                <a16:creationId xmlns:a16="http://schemas.microsoft.com/office/drawing/2014/main" id="{D8FD0815-C384-4769-DFCD-29D899DF4E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FA3B6-098D-4AFF-A6E1-6FF6E547B543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4" name="Θέση υποσέλιδου 3">
            <a:extLst>
              <a:ext uri="{FF2B5EF4-FFF2-40B4-BE49-F238E27FC236}">
                <a16:creationId xmlns:a16="http://schemas.microsoft.com/office/drawing/2014/main" id="{1196EA69-50E4-CED4-B4E0-E619922E9B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Θέση αριθμού διαφάνειας 4">
            <a:extLst>
              <a:ext uri="{FF2B5EF4-FFF2-40B4-BE49-F238E27FC236}">
                <a16:creationId xmlns:a16="http://schemas.microsoft.com/office/drawing/2014/main" id="{7752B275-497A-1300-70CA-483593ADB8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8ADE6-8438-47CA-8259-E752C44071B0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6613655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ημερομηνίας 1">
            <a:extLst>
              <a:ext uri="{FF2B5EF4-FFF2-40B4-BE49-F238E27FC236}">
                <a16:creationId xmlns:a16="http://schemas.microsoft.com/office/drawing/2014/main" id="{D82D2E7F-1B72-EECD-1DC4-6E2AF058C7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FA3B6-098D-4AFF-A6E1-6FF6E547B543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3" name="Θέση υποσέλιδου 2">
            <a:extLst>
              <a:ext uri="{FF2B5EF4-FFF2-40B4-BE49-F238E27FC236}">
                <a16:creationId xmlns:a16="http://schemas.microsoft.com/office/drawing/2014/main" id="{6175A850-C72E-9C0E-0F00-EFE68422DB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Θέση αριθμού διαφάνειας 3">
            <a:extLst>
              <a:ext uri="{FF2B5EF4-FFF2-40B4-BE49-F238E27FC236}">
                <a16:creationId xmlns:a16="http://schemas.microsoft.com/office/drawing/2014/main" id="{A190BE03-C527-BC26-E665-B78AB153D9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8ADE6-8438-47CA-8259-E752C44071B0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7194696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C2571C9F-2E31-B28D-6275-E5C069086E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358C8771-F15A-27E4-E3C7-0ADA568CB9A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κειμένου 3">
            <a:extLst>
              <a:ext uri="{FF2B5EF4-FFF2-40B4-BE49-F238E27FC236}">
                <a16:creationId xmlns:a16="http://schemas.microsoft.com/office/drawing/2014/main" id="{178D5B0B-4DF9-D70B-F1DD-8E67CBE9D0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606C0B13-9A7B-4092-9B77-E0F4DBA9C1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FA3B6-098D-4AFF-A6E1-6FF6E547B543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BEC88A60-F693-9158-3081-0E7FEAB342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1CC84F86-FBCB-9CCA-2156-24248815EF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8ADE6-8438-47CA-8259-E752C44071B0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9648323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384AD0B6-4DC4-1CE4-7FF5-E9CC670FBB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εικόνας 2">
            <a:extLst>
              <a:ext uri="{FF2B5EF4-FFF2-40B4-BE49-F238E27FC236}">
                <a16:creationId xmlns:a16="http://schemas.microsoft.com/office/drawing/2014/main" id="{396D2E9C-106E-F9FB-B1DE-1B8033E513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Θέση κειμένου 3">
            <a:extLst>
              <a:ext uri="{FF2B5EF4-FFF2-40B4-BE49-F238E27FC236}">
                <a16:creationId xmlns:a16="http://schemas.microsoft.com/office/drawing/2014/main" id="{1F86C13F-BA93-1555-BE0D-30BA142871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061A2F57-8526-8670-A6E8-68A6BAABD8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FA3B6-098D-4AFF-A6E1-6FF6E547B543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AAA0FC49-7C66-16E1-6B11-5388348BB8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A44B3491-CFB0-EEB8-C142-725BC2294B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8ADE6-8438-47CA-8259-E752C44071B0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904111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τίτλου 1">
            <a:extLst>
              <a:ext uri="{FF2B5EF4-FFF2-40B4-BE49-F238E27FC236}">
                <a16:creationId xmlns:a16="http://schemas.microsoft.com/office/drawing/2014/main" id="{F57915FB-26C1-EDAF-7838-1C86837B22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17376492-F08F-B3CE-05C5-D6E90A5ABD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7C36B45A-36AC-5EAB-EF35-9E2D09F5759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CFA3B6-098D-4AFF-A6E1-6FF6E547B543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3BDC64E9-6A16-864C-00FE-FB4A46C897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947B001B-844C-7A18-2DB4-359F9F18079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D8ADE6-8438-47CA-8259-E752C44071B0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920148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Θέση περιεχομένου 4">
            <a:extLst>
              <a:ext uri="{FF2B5EF4-FFF2-40B4-BE49-F238E27FC236}">
                <a16:creationId xmlns:a16="http://schemas.microsoft.com/office/drawing/2014/main" id="{23355305-8C6F-DB3E-1D45-4FD6E44A8A1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4874" y="182562"/>
            <a:ext cx="8882252" cy="6492875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0A075F8-D421-00D6-4147-43EE1A00105D}"/>
              </a:ext>
            </a:extLst>
          </p:cNvPr>
          <p:cNvSpPr txBox="1"/>
          <p:nvPr/>
        </p:nvSpPr>
        <p:spPr>
          <a:xfrm>
            <a:off x="491067" y="636600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4a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268400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Εικόνα 5">
            <a:extLst>
              <a:ext uri="{FF2B5EF4-FFF2-40B4-BE49-F238E27FC236}">
                <a16:creationId xmlns:a16="http://schemas.microsoft.com/office/drawing/2014/main" id="{550C1DF9-309D-C267-EF3F-5990559C0DB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7930" y="86894"/>
            <a:ext cx="9144000" cy="668421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DD04416-80E4-C4EE-D862-24987BB54FBE}"/>
              </a:ext>
            </a:extLst>
          </p:cNvPr>
          <p:cNvSpPr txBox="1"/>
          <p:nvPr/>
        </p:nvSpPr>
        <p:spPr>
          <a:xfrm>
            <a:off x="660400" y="670467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4b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15751442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Θέση περιεχομένου 4">
            <a:extLst>
              <a:ext uri="{FF2B5EF4-FFF2-40B4-BE49-F238E27FC236}">
                <a16:creationId xmlns:a16="http://schemas.microsoft.com/office/drawing/2014/main" id="{08E2ED01-6F2A-442B-B0CA-8E1D48A268D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8943" y="233469"/>
            <a:ext cx="9062357" cy="6624531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5174A58-6F67-8AB5-809B-F9D287F25026}"/>
              </a:ext>
            </a:extLst>
          </p:cNvPr>
          <p:cNvSpPr txBox="1"/>
          <p:nvPr/>
        </p:nvSpPr>
        <p:spPr>
          <a:xfrm>
            <a:off x="558800" y="619667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4c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14092497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Θέση περιεχομένου 4">
            <a:extLst>
              <a:ext uri="{FF2B5EF4-FFF2-40B4-BE49-F238E27FC236}">
                <a16:creationId xmlns:a16="http://schemas.microsoft.com/office/drawing/2014/main" id="{ECDD6150-FEA9-5505-9517-D9C45A60553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3243" y="231279"/>
            <a:ext cx="8784771" cy="6421618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684BD8D-1C46-6089-9A87-79257CF354EB}"/>
              </a:ext>
            </a:extLst>
          </p:cNvPr>
          <p:cNvSpPr txBox="1"/>
          <p:nvPr/>
        </p:nvSpPr>
        <p:spPr>
          <a:xfrm>
            <a:off x="762000" y="585801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4d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5676425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Θέση περιεχομένου 4">
            <a:extLst>
              <a:ext uri="{FF2B5EF4-FFF2-40B4-BE49-F238E27FC236}">
                <a16:creationId xmlns:a16="http://schemas.microsoft.com/office/drawing/2014/main" id="{286E8711-FE32-FB75-DE38-72F7AF920D4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4628" y="182382"/>
            <a:ext cx="8882743" cy="6493235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8C67429-F59F-A1A6-C96C-1F73B117AE02}"/>
              </a:ext>
            </a:extLst>
          </p:cNvPr>
          <p:cNvSpPr txBox="1"/>
          <p:nvPr/>
        </p:nvSpPr>
        <p:spPr>
          <a:xfrm>
            <a:off x="508000" y="636601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4e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540629362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20</TotalTime>
  <Words>303</Words>
  <Application>Microsoft Office PowerPoint</Application>
  <PresentationFormat>Ευρεία οθόνη</PresentationFormat>
  <Paragraphs>20</Paragraphs>
  <Slides>5</Slides>
  <Notes>5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4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Θέμα του Office</vt:lpstr>
      <vt:lpstr>Παρουσίαση του PowerPoint</vt:lpstr>
      <vt:lpstr>Παρουσίαση του PowerPoint</vt:lpstr>
      <vt:lpstr>Παρουσίαση του PowerPoint</vt:lpstr>
      <vt:lpstr>Παρουσίαση του PowerPoint</vt:lpstr>
      <vt:lpstr>Παρουσίαση του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Ioanna Filimidou</dc:creator>
  <cp:lastModifiedBy>Ioanna Filimidou</cp:lastModifiedBy>
  <cp:revision>24</cp:revision>
  <dcterms:created xsi:type="dcterms:W3CDTF">2024-12-08T14:55:32Z</dcterms:created>
  <dcterms:modified xsi:type="dcterms:W3CDTF">2025-02-27T21:02:42Z</dcterms:modified>
</cp:coreProperties>
</file>